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942093"/>
    <a:srgbClr val="9437FF"/>
    <a:srgbClr val="FF9300"/>
    <a:srgbClr val="929292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04"/>
    <p:restoredTop sz="96310"/>
  </p:normalViewPr>
  <p:slideViewPr>
    <p:cSldViewPr snapToGrid="0">
      <p:cViewPr varScale="1">
        <p:scale>
          <a:sx n="103" d="100"/>
          <a:sy n="103" d="100"/>
        </p:scale>
        <p:origin x="48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A4D8E-4468-8940-8495-075939C632A2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E1239-6483-EE4F-A3E6-E515071B15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59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02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356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75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528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317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9112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17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4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312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499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68482E-6BF0-2B4F-B79D-0E9C1F630644}" type="datetimeFigureOut">
              <a:rPr lang="en-US" smtClean="0"/>
              <a:t>9/1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47329A-A6B8-C942-A020-217946793E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78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9A08DFB3-D1CB-500C-2407-9CE63C4F220A}"/>
              </a:ext>
            </a:extLst>
          </p:cNvPr>
          <p:cNvSpPr/>
          <p:nvPr/>
        </p:nvSpPr>
        <p:spPr>
          <a:xfrm>
            <a:off x="1570296" y="701365"/>
            <a:ext cx="2925221" cy="46591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PROCEED Study </a:t>
            </a:r>
          </a:p>
          <a:p>
            <a:pPr algn="ctr"/>
            <a:r>
              <a:rPr lang="en-US" sz="1400" dirty="0">
                <a:solidFill>
                  <a:schemeClr val="tx1"/>
                </a:solidFill>
              </a:rPr>
              <a:t>n=1,976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EBD30B3-E625-D90D-AE50-48531C0A6EF5}"/>
              </a:ext>
            </a:extLst>
          </p:cNvPr>
          <p:cNvSpPr/>
          <p:nvPr/>
        </p:nvSpPr>
        <p:spPr>
          <a:xfrm>
            <a:off x="1557307" y="1424658"/>
            <a:ext cx="2925227" cy="46591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PRIME Sub-cohort 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CD3B0D3-654D-4417-F490-27F9FE761A5E}"/>
              </a:ext>
            </a:extLst>
          </p:cNvPr>
          <p:cNvCxnSpPr>
            <a:cxnSpLocks/>
          </p:cNvCxnSpPr>
          <p:nvPr/>
        </p:nvCxnSpPr>
        <p:spPr>
          <a:xfrm>
            <a:off x="3077823" y="1167278"/>
            <a:ext cx="0" cy="2343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588AFC4C-5B11-B1FA-97E1-24F33B737C35}"/>
              </a:ext>
            </a:extLst>
          </p:cNvPr>
          <p:cNvSpPr/>
          <p:nvPr/>
        </p:nvSpPr>
        <p:spPr>
          <a:xfrm>
            <a:off x="1570958" y="2144812"/>
            <a:ext cx="2911577" cy="58494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Banked PBMCs: Function assay (Fig 1) n=106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E394C6B-A299-B01E-058E-36C738F8FADA}"/>
              </a:ext>
            </a:extLst>
          </p:cNvPr>
          <p:cNvSpPr/>
          <p:nvPr/>
        </p:nvSpPr>
        <p:spPr>
          <a:xfrm>
            <a:off x="1557308" y="3004753"/>
            <a:ext cx="2925238" cy="58494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Sufficient DNA for qPCR SNP array</a:t>
            </a:r>
          </a:p>
          <a:p>
            <a:pPr algn="ctr"/>
            <a:r>
              <a:rPr lang="en-US" sz="1400" dirty="0">
                <a:solidFill>
                  <a:schemeClr val="tx1"/>
                </a:solidFill>
              </a:rPr>
              <a:t>n=10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1FE70C-4FCB-2956-B13B-D914C43C814A}"/>
              </a:ext>
            </a:extLst>
          </p:cNvPr>
          <p:cNvSpPr txBox="1"/>
          <p:nvPr/>
        </p:nvSpPr>
        <p:spPr>
          <a:xfrm>
            <a:off x="42138" y="39785"/>
            <a:ext cx="1948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60D196-0169-72A9-B2F9-CBB8A76AF9F3}"/>
              </a:ext>
            </a:extLst>
          </p:cNvPr>
          <p:cNvSpPr txBox="1"/>
          <p:nvPr/>
        </p:nvSpPr>
        <p:spPr>
          <a:xfrm>
            <a:off x="29324" y="321147"/>
            <a:ext cx="2097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 Discovery cohort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7530BE8-7AEC-9E13-1207-C341B1052A98}"/>
              </a:ext>
            </a:extLst>
          </p:cNvPr>
          <p:cNvSpPr txBox="1"/>
          <p:nvPr/>
        </p:nvSpPr>
        <p:spPr>
          <a:xfrm>
            <a:off x="42138" y="4103812"/>
            <a:ext cx="2129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 Validation cohort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F1AAED8-5674-39F4-A97E-6727987FB3E5}"/>
              </a:ext>
            </a:extLst>
          </p:cNvPr>
          <p:cNvSpPr/>
          <p:nvPr/>
        </p:nvSpPr>
        <p:spPr>
          <a:xfrm>
            <a:off x="1557307" y="4567230"/>
            <a:ext cx="2938210" cy="789363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err="1">
                <a:solidFill>
                  <a:schemeClr val="tx1"/>
                </a:solidFill>
              </a:rPr>
              <a:t>Karmanos</a:t>
            </a:r>
            <a:r>
              <a:rPr lang="en-US" sz="1600" dirty="0">
                <a:solidFill>
                  <a:schemeClr val="tx1"/>
                </a:solidFill>
              </a:rPr>
              <a:t> Cancer Institute cohort (Heath et al 2024) (n=57)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CCBE1E76-C616-7D94-1804-F9D8164CC910}"/>
              </a:ext>
            </a:extLst>
          </p:cNvPr>
          <p:cNvCxnSpPr>
            <a:cxnSpLocks/>
          </p:cNvCxnSpPr>
          <p:nvPr/>
        </p:nvCxnSpPr>
        <p:spPr>
          <a:xfrm>
            <a:off x="3085149" y="1890571"/>
            <a:ext cx="0" cy="2343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06624D14-D82F-5AC4-9086-DE8DE1FDD5E8}"/>
              </a:ext>
            </a:extLst>
          </p:cNvPr>
          <p:cNvCxnSpPr>
            <a:cxnSpLocks/>
          </p:cNvCxnSpPr>
          <p:nvPr/>
        </p:nvCxnSpPr>
        <p:spPr>
          <a:xfrm>
            <a:off x="3085149" y="2729755"/>
            <a:ext cx="0" cy="2343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93C15A04-7A60-A0DC-3FD0-36C41B72A3B7}"/>
              </a:ext>
            </a:extLst>
          </p:cNvPr>
          <p:cNvSpPr/>
          <p:nvPr/>
        </p:nvSpPr>
        <p:spPr>
          <a:xfrm>
            <a:off x="1544325" y="6797680"/>
            <a:ext cx="2938209" cy="704245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Available post-sip-T survival information (n=28)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8D11D93D-C593-399F-1C48-2073A5AADEB6}"/>
              </a:ext>
            </a:extLst>
          </p:cNvPr>
          <p:cNvCxnSpPr>
            <a:cxnSpLocks/>
          </p:cNvCxnSpPr>
          <p:nvPr/>
        </p:nvCxnSpPr>
        <p:spPr>
          <a:xfrm>
            <a:off x="2968940" y="5410518"/>
            <a:ext cx="0" cy="2343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05E75F3E-900F-2F14-E250-08E485D52E1D}"/>
              </a:ext>
            </a:extLst>
          </p:cNvPr>
          <p:cNvSpPr/>
          <p:nvPr/>
        </p:nvSpPr>
        <p:spPr>
          <a:xfrm>
            <a:off x="1554063" y="5715136"/>
            <a:ext cx="2918732" cy="73257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Patients with available pre-treatment PBMCs n=30: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Function assay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1683DCEE-BFAE-AD0E-88D8-A29268E2CA0F}"/>
              </a:ext>
            </a:extLst>
          </p:cNvPr>
          <p:cNvCxnSpPr>
            <a:cxnSpLocks/>
          </p:cNvCxnSpPr>
          <p:nvPr/>
        </p:nvCxnSpPr>
        <p:spPr>
          <a:xfrm>
            <a:off x="2968940" y="6483331"/>
            <a:ext cx="0" cy="23439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D5B38FA-701E-BC45-992F-DEA0AB043F08}"/>
              </a:ext>
            </a:extLst>
          </p:cNvPr>
          <p:cNvSpPr txBox="1"/>
          <p:nvPr/>
        </p:nvSpPr>
        <p:spPr>
          <a:xfrm>
            <a:off x="0" y="7548637"/>
            <a:ext cx="6815862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Consort diagram.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ients with available PBMCs, survival information, and self-reported race from the PRIME subset study of the PROCEED registry were eligible for this study. All PBMCs were tested in an in vitro functional assay (n=106), with qPCR SNP array performed on n=103 with sufficient recovered DNA. Comparisons of in vitro functional assay outputs with other pre-existing ELISpot, ELISA, and vaccine manufacture quality control (CD54 </a:t>
            </a:r>
            <a:r>
              <a:rPr lang="en-US" sz="12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preg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TNC) data sets were performed according to the availability of these metrics matched to each patient from the parent PRIME study. (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Patients with available pre-sip-T treatment PBMCs, survival information, and self-reported race were used to validate findings in the PBMC function assays. 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8790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56</TotalTime>
  <Words>210</Words>
  <Application>Microsoft Macintosh PowerPoint</Application>
  <PresentationFormat>Letter Paper (8.5x11 in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Brown</dc:creator>
  <cp:lastModifiedBy>Michael Brown</cp:lastModifiedBy>
  <cp:revision>33</cp:revision>
  <dcterms:created xsi:type="dcterms:W3CDTF">2024-05-14T01:47:53Z</dcterms:created>
  <dcterms:modified xsi:type="dcterms:W3CDTF">2024-09-16T19:24:32Z</dcterms:modified>
</cp:coreProperties>
</file>